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717" autoAdjust="0"/>
    <p:restoredTop sz="94660"/>
  </p:normalViewPr>
  <p:slideViewPr>
    <p:cSldViewPr>
      <p:cViewPr varScale="1">
        <p:scale>
          <a:sx n="74" d="100"/>
          <a:sy n="74" d="100"/>
        </p:scale>
        <p:origin x="-40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309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426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993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357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003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4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85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879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378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401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208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4DC7D8-3411-4951-A924-22338434F2E5}" type="datetimeFigureOut">
              <a:rPr lang="en-US" smtClean="0"/>
              <a:t>1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C6888-A943-4DB5-BDDB-59871901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489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E-cigarette Ads Shown to Participa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15023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R:\Smith, Danielle\DS Projects\Integrative Project - E-cig marketing pilot\Ads to use\Ads to use\Ad#17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152400"/>
            <a:ext cx="4756706" cy="6516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403790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 smtClean="0"/>
              <a:t>Snus</a:t>
            </a:r>
            <a:r>
              <a:rPr lang="en-US" dirty="0" smtClean="0"/>
              <a:t> Ads shown to participan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24229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R:\Smith, Danielle\DS Projects\Integrative Project - E-cig marketing pilot\Ads to use\Ads to use\Ad#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0" y="533400"/>
            <a:ext cx="5096612" cy="5827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9355653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R:\Smith, Danielle\DS Projects\Integrative Project - E-cig marketing pilot\Ads to use\Ads to use\Ad#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228600"/>
            <a:ext cx="4495800" cy="62533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2624851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 descr="R:\Smith, Danielle\DS Projects\Integrative Project - E-cig marketing pilot\Ads to use\Ads to use\Ad#7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555" y="228600"/>
            <a:ext cx="8572500" cy="59912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24585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R:\Smith, Danielle\DS Projects\Integrative Project - E-cig marketing pilot\Ads to use\Ads to use\Ad#8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304800"/>
            <a:ext cx="4408488" cy="62747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9784161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R:\Smith, Danielle\DS Projects\Integrative Project - E-cig marketing pilot\Ads to use\Ads to use\Ad#1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304800"/>
            <a:ext cx="4621169" cy="6176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187429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R:\Smith, Danielle\DS Projects\Integrative Project - E-cig marketing pilot\Ads to use\Ads to use\Ad#13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0200" y="152400"/>
            <a:ext cx="5522360" cy="655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5669279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 descr="R:\Smith, Danielle\DS Projects\Integrative Project - E-cig marketing pilot\Ads to use\Ads to use\Ad#1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0" y="304800"/>
            <a:ext cx="4617655" cy="63261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8009786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R:\Smith, Danielle\DS Projects\Integrative Project - E-cig marketing pilot\Ads to use\Ads to use\Ad#1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0" y="76200"/>
            <a:ext cx="4572000" cy="6496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27657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R:\Smith, Danielle\DS Projects\Integrative Project - E-cig marketing pilot\Ads to use\Ads to use\Ad#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102435"/>
            <a:ext cx="4648200" cy="65384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9246610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R:\Smith, Danielle\DS Projects\Integrative Project - E-cig marketing pilot\Ads to use\Ads to use\Ad#18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7400" y="106363"/>
            <a:ext cx="4762500" cy="6638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157561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R:\Smith, Danielle\DS Projects\Integrative Project - E-cig marketing pilot\Ads to use\Ads to use\Ad#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304799"/>
            <a:ext cx="4609211" cy="6253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216705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R:\Smith, Danielle\DS Projects\Integrative Project - E-cig marketing pilot\Ads to use\Ads to use\Ad#3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228600"/>
            <a:ext cx="4652149" cy="63579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70991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R:\Smith, Danielle\DS Projects\Integrative Project - E-cig marketing pilot\Ads to use\Ads to use\Ad#5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228600"/>
            <a:ext cx="5875663" cy="609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149470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2100664"/>
            <a:ext cx="6048143" cy="277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12925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R:\Smith, Danielle\DS Projects\Integrative Project - E-cig marketing pilot\Ads to use\Ads to use\Ad#10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5999" y="228600"/>
            <a:ext cx="4382627" cy="6172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510355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R:\Smith, Danielle\DS Projects\Integrative Project - E-cig marketing pilot\Ads to use\Ads to use\Ad#1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800" y="228600"/>
            <a:ext cx="4499309" cy="6269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390650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R:\Smith, Danielle\DS Projects\Integrative Project - E-cig marketing pilot\Ads to use\Ads to use\Ad#15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304799"/>
            <a:ext cx="4953000" cy="6191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25634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0</Words>
  <Application>Microsoft Office PowerPoint</Application>
  <PresentationFormat>On-screen Show (4:3)</PresentationFormat>
  <Paragraphs>2</Paragraphs>
  <Slides>2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E-cigarette Ads Shown to Participant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nus Ads shown to participant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oswell Park Cancer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-cigarette Ads Shown to Participants</dc:title>
  <dc:creator>Danielle Smith</dc:creator>
  <cp:lastModifiedBy>Danielle Smith</cp:lastModifiedBy>
  <cp:revision>1</cp:revision>
  <dcterms:created xsi:type="dcterms:W3CDTF">2014-01-30T16:00:01Z</dcterms:created>
  <dcterms:modified xsi:type="dcterms:W3CDTF">2014-01-30T16:07:46Z</dcterms:modified>
</cp:coreProperties>
</file>